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69" r:id="rId2"/>
    <p:sldId id="281" r:id="rId3"/>
    <p:sldId id="284" r:id="rId4"/>
    <p:sldId id="283" r:id="rId5"/>
    <p:sldId id="286" r:id="rId6"/>
  </p:sldIdLst>
  <p:sldSz cx="6858000" cy="9144000" type="screen4x3"/>
  <p:notesSz cx="6858000" cy="91440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90" autoAdjust="0"/>
    <p:restoredTop sz="94286"/>
  </p:normalViewPr>
  <p:slideViewPr>
    <p:cSldViewPr>
      <p:cViewPr varScale="1">
        <p:scale>
          <a:sx n="61" d="100"/>
          <a:sy n="61" d="100"/>
        </p:scale>
        <p:origin x="2736" y="67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eshinya_1\Desktop\submitting\CRT&#20013;&#20307;&#37325;&#28187;&#23569;&#35542;&#25991;\Tba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eshinya_1\Desktop\submitting\CRT&#20013;&#20307;&#37325;&#28187;&#23569;&#35542;&#25991;\Tba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eshinya_1\Desktop\submitting\CRT&#20013;&#20307;&#37325;&#28187;&#23569;&#35542;&#25991;\Tbal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傾向検定'!$C$9</c:f>
              <c:strCache>
                <c:ptCount val="1"/>
                <c:pt idx="0">
                  <c:v>Below the median of PMI los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傾向検定'!$B$10:$B$13</c:f>
              <c:strCache>
                <c:ptCount val="4"/>
                <c:pt idx="0">
                  <c:v>Weight Gain</c:v>
                </c:pt>
                <c:pt idx="1">
                  <c:v>WL 0-5%</c:v>
                </c:pt>
                <c:pt idx="2">
                  <c:v>WL 5-10%</c:v>
                </c:pt>
                <c:pt idx="3">
                  <c:v>WL ≥10% </c:v>
                </c:pt>
              </c:strCache>
            </c:strRef>
          </c:cat>
          <c:val>
            <c:numRef>
              <c:f>'Figure 傾向検定'!$C$10:$C$13</c:f>
              <c:numCache>
                <c:formatCode>General</c:formatCode>
                <c:ptCount val="4"/>
                <c:pt idx="0">
                  <c:v>43.636363636363633</c:v>
                </c:pt>
                <c:pt idx="1">
                  <c:v>52.89855072463768</c:v>
                </c:pt>
                <c:pt idx="2">
                  <c:v>61.403508771929829</c:v>
                </c:pt>
                <c:pt idx="3">
                  <c:v>42.1052631578947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11-0349-89DB-741C5587C2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96013824"/>
        <c:axId val="896009472"/>
      </c:barChart>
      <c:catAx>
        <c:axId val="896013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009472"/>
        <c:crosses val="autoZero"/>
        <c:auto val="1"/>
        <c:lblAlgn val="ctr"/>
        <c:lblOffset val="100"/>
        <c:noMultiLvlLbl val="0"/>
      </c:catAx>
      <c:valAx>
        <c:axId val="89600947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01382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傾向検定'!$H$9</c:f>
              <c:strCache>
                <c:ptCount val="1"/>
                <c:pt idx="0">
                  <c:v>Below the median of VFI los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傾向検定'!$G$10:$G$13</c:f>
              <c:strCache>
                <c:ptCount val="4"/>
                <c:pt idx="0">
                  <c:v>Weight Gain</c:v>
                </c:pt>
                <c:pt idx="1">
                  <c:v>WL 0-5%</c:v>
                </c:pt>
                <c:pt idx="2">
                  <c:v>WL 5-10%</c:v>
                </c:pt>
                <c:pt idx="3">
                  <c:v>WL ≥10% </c:v>
                </c:pt>
              </c:strCache>
            </c:strRef>
          </c:cat>
          <c:val>
            <c:numRef>
              <c:f>'Figure 傾向検定'!$H$10:$H$13</c:f>
              <c:numCache>
                <c:formatCode>General</c:formatCode>
                <c:ptCount val="4"/>
                <c:pt idx="0">
                  <c:v>16.363636363636363</c:v>
                </c:pt>
                <c:pt idx="1">
                  <c:v>42.753623188405797</c:v>
                </c:pt>
                <c:pt idx="2">
                  <c:v>61.403508771929829</c:v>
                </c:pt>
                <c:pt idx="3">
                  <c:v>81.5789473684210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D5-3E4B-B330-BBA08D40BB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96016000"/>
        <c:axId val="896020352"/>
      </c:barChart>
      <c:catAx>
        <c:axId val="896016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020352"/>
        <c:crosses val="autoZero"/>
        <c:auto val="1"/>
        <c:lblAlgn val="ctr"/>
        <c:lblOffset val="100"/>
        <c:noMultiLvlLbl val="0"/>
      </c:catAx>
      <c:valAx>
        <c:axId val="89602035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01600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傾向検定'!$M$9</c:f>
              <c:strCache>
                <c:ptCount val="1"/>
                <c:pt idx="0">
                  <c:v>Below the median of SFI loss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Figure 傾向検定'!$L$10:$L$13</c:f>
              <c:strCache>
                <c:ptCount val="4"/>
                <c:pt idx="0">
                  <c:v>Weight Gain</c:v>
                </c:pt>
                <c:pt idx="1">
                  <c:v>WL 0-5%</c:v>
                </c:pt>
                <c:pt idx="2">
                  <c:v>WL 5-10%</c:v>
                </c:pt>
                <c:pt idx="3">
                  <c:v>WL ≥10% </c:v>
                </c:pt>
              </c:strCache>
            </c:strRef>
          </c:cat>
          <c:val>
            <c:numRef>
              <c:f>'Figure 傾向検定'!$M$10:$M$13</c:f>
              <c:numCache>
                <c:formatCode>General</c:formatCode>
                <c:ptCount val="4"/>
                <c:pt idx="0">
                  <c:v>20</c:v>
                </c:pt>
                <c:pt idx="1">
                  <c:v>53.623188405797109</c:v>
                </c:pt>
                <c:pt idx="2">
                  <c:v>75.438596491228068</c:v>
                </c:pt>
                <c:pt idx="3">
                  <c:v>86.8421052631579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82-3B45-A9AA-9F713DE76C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96016544"/>
        <c:axId val="896011104"/>
      </c:barChart>
      <c:catAx>
        <c:axId val="896016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011104"/>
        <c:crosses val="autoZero"/>
        <c:auto val="1"/>
        <c:lblAlgn val="ctr"/>
        <c:lblOffset val="100"/>
        <c:noMultiLvlLbl val="0"/>
      </c:catAx>
      <c:valAx>
        <c:axId val="8960111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01654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8392D505-FB1A-104D-84B8-F101DD643219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B2834B6-7B84-E64D-8C3E-7D66514A1B6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</a:lstStyle>
          <a:p>
            <a:pPr>
              <a:defRPr/>
            </a:pPr>
            <a:fld id="{FC815570-1353-894C-A417-9AE24EB1D98B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29110EB-0B17-5344-9D06-A7E46ED0228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844D15E-E134-4B46-AA3D-5D25735941F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游ゴシック" panose="020B0400000000000000" pitchFamily="34" charset="-128"/>
                <a:ea typeface="游ゴシック" panose="020B0400000000000000" pitchFamily="34" charset="-128"/>
              </a:defRPr>
            </a:lvl1pPr>
          </a:lstStyle>
          <a:p>
            <a:fld id="{039D4156-BD99-C741-9380-01930071641C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449F4481-D0F4-3440-968C-D23AD185619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C855BB9-5262-CB43-BBD5-EE0B7BA35614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7FCD0A9D-A99C-3A46-907D-1BCF408C0D90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F95487B9-D4D9-ED4A-BA86-5510860B1DDA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34B46895-58A3-1C4E-B0FD-56C65AE820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3250D3-22F2-3E42-9D23-F8DF4C6C9EE7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879ABAD-EABF-BC49-A8AF-7CA04863596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4D44B4F8-E46A-554E-A93F-9137B2F9829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7956761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anose="020B0600070205080204" pitchFamily="34" charset="-128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スライド イメージ プレースホルダー 1">
            <a:extLst>
              <a:ext uri="{FF2B5EF4-FFF2-40B4-BE49-F238E27FC236}">
                <a16:creationId xmlns:a16="http://schemas.microsoft.com/office/drawing/2014/main" id="{37E8B73D-ABE7-A295-C6E4-EE0BEF07DC93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xfrm>
            <a:off x="2143125" y="685800"/>
            <a:ext cx="257175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ノート プレースホルダー 2">
            <a:extLst>
              <a:ext uri="{FF2B5EF4-FFF2-40B4-BE49-F238E27FC236}">
                <a16:creationId xmlns:a16="http://schemas.microsoft.com/office/drawing/2014/main" id="{C9189DBE-DACB-36AF-CC26-7C335F7E421D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ja-JP" dirty="0"/>
          </a:p>
        </p:txBody>
      </p:sp>
      <p:sp>
        <p:nvSpPr>
          <p:cNvPr id="5124" name="スライド番号プレースホルダー 3">
            <a:extLst>
              <a:ext uri="{FF2B5EF4-FFF2-40B4-BE49-F238E27FC236}">
                <a16:creationId xmlns:a16="http://schemas.microsoft.com/office/drawing/2014/main" id="{128E6A71-95A0-787A-8733-9C5A0424F733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fld id="{4273A317-F467-E545-AFCA-5AF9132E8A3A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698472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ED48BC-7DFF-F111-1AFB-C750C79F33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スライド イメージ プレースホルダー 1">
            <a:extLst>
              <a:ext uri="{FF2B5EF4-FFF2-40B4-BE49-F238E27FC236}">
                <a16:creationId xmlns:a16="http://schemas.microsoft.com/office/drawing/2014/main" id="{CE5A56FD-B486-573E-9FA9-A957DAE36E2E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143125" y="685800"/>
            <a:ext cx="257175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0482" name="ノート プレースホルダー 2">
            <a:extLst>
              <a:ext uri="{FF2B5EF4-FFF2-40B4-BE49-F238E27FC236}">
                <a16:creationId xmlns:a16="http://schemas.microsoft.com/office/drawing/2014/main" id="{BA3C3160-B97E-8779-E444-7A41AD387D5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/>
          </a:p>
        </p:txBody>
      </p:sp>
      <p:sp>
        <p:nvSpPr>
          <p:cNvPr id="20483" name="スライド番号プレースホルダー 3">
            <a:extLst>
              <a:ext uri="{FF2B5EF4-FFF2-40B4-BE49-F238E27FC236}">
                <a16:creationId xmlns:a16="http://schemas.microsoft.com/office/drawing/2014/main" id="{553F8D2E-CC52-9B33-0968-33DD8D624AA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fld id="{3068B062-6514-7342-8185-0EF4B0944397}" type="slidenum">
              <a:rPr lang="ja-JP" altLang="en-US"/>
              <a:pPr/>
              <a:t>2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775184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2410CFE-292D-C382-F366-C52261E26E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スライド イメージ プレースホルダー 1">
            <a:extLst>
              <a:ext uri="{FF2B5EF4-FFF2-40B4-BE49-F238E27FC236}">
                <a16:creationId xmlns:a16="http://schemas.microsoft.com/office/drawing/2014/main" id="{A3056F6C-DA4E-A596-D575-5D86C0557C6E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143125" y="685800"/>
            <a:ext cx="257175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0" name="ノート プレースホルダー 2">
            <a:extLst>
              <a:ext uri="{FF2B5EF4-FFF2-40B4-BE49-F238E27FC236}">
                <a16:creationId xmlns:a16="http://schemas.microsoft.com/office/drawing/2014/main" id="{FA06D4D9-77ED-6DE4-F6C9-FB95616852BE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/>
          </a:p>
        </p:txBody>
      </p:sp>
      <p:sp>
        <p:nvSpPr>
          <p:cNvPr id="22531" name="スライド番号プレースホルダー 3">
            <a:extLst>
              <a:ext uri="{FF2B5EF4-FFF2-40B4-BE49-F238E27FC236}">
                <a16:creationId xmlns:a16="http://schemas.microsoft.com/office/drawing/2014/main" id="{D0C81F90-12AA-7EA3-0F65-038BA84EBAC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fld id="{B2239B96-7A04-6940-8A3B-9DCF37AC56E5}" type="slidenum">
              <a:rPr lang="ja-JP" altLang="en-US"/>
              <a:pPr/>
              <a:t>3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426383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スライド イメージ プレースホルダー 1">
            <a:extLst>
              <a:ext uri="{FF2B5EF4-FFF2-40B4-BE49-F238E27FC236}">
                <a16:creationId xmlns:a16="http://schemas.microsoft.com/office/drawing/2014/main" id="{45E79812-02EF-3A62-8911-01C821952F90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143125" y="685800"/>
            <a:ext cx="257175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0" name="ノート プレースホルダー 2">
            <a:extLst>
              <a:ext uri="{FF2B5EF4-FFF2-40B4-BE49-F238E27FC236}">
                <a16:creationId xmlns:a16="http://schemas.microsoft.com/office/drawing/2014/main" id="{1C4C46DE-B05F-E34A-5ACF-A47A71A5DAD2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/>
          </a:p>
        </p:txBody>
      </p:sp>
      <p:sp>
        <p:nvSpPr>
          <p:cNvPr id="22531" name="スライド番号プレースホルダー 3">
            <a:extLst>
              <a:ext uri="{FF2B5EF4-FFF2-40B4-BE49-F238E27FC236}">
                <a16:creationId xmlns:a16="http://schemas.microsoft.com/office/drawing/2014/main" id="{5345E49F-861F-83E7-10E7-5687D4AB277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fld id="{B2239B96-7A04-6940-8A3B-9DCF37AC56E5}" type="slidenum">
              <a:rPr lang="ja-JP" altLang="en-US"/>
              <a:pPr/>
              <a:t>4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0192545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スライド イメージ プレースホルダー 1">
            <a:extLst>
              <a:ext uri="{FF2B5EF4-FFF2-40B4-BE49-F238E27FC236}">
                <a16:creationId xmlns:a16="http://schemas.microsoft.com/office/drawing/2014/main" id="{45E79812-02EF-3A62-8911-01C821952F90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143125" y="685800"/>
            <a:ext cx="257175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0" name="ノート プレースホルダー 2">
            <a:extLst>
              <a:ext uri="{FF2B5EF4-FFF2-40B4-BE49-F238E27FC236}">
                <a16:creationId xmlns:a16="http://schemas.microsoft.com/office/drawing/2014/main" id="{1C4C46DE-B05F-E34A-5ACF-A47A71A5DAD2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/>
          </a:p>
        </p:txBody>
      </p:sp>
      <p:sp>
        <p:nvSpPr>
          <p:cNvPr id="22531" name="スライド番号プレースホルダー 3">
            <a:extLst>
              <a:ext uri="{FF2B5EF4-FFF2-40B4-BE49-F238E27FC236}">
                <a16:creationId xmlns:a16="http://schemas.microsoft.com/office/drawing/2014/main" id="{5345E49F-861F-83E7-10E7-5687D4AB277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fld id="{B2239B96-7A04-6940-8A3B-9DCF37AC56E5}" type="slidenum">
              <a:rPr lang="ja-JP" altLang="en-US"/>
              <a:pPr/>
              <a:t>5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234246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87C6446C-3E9C-73E4-FD6E-A3E293E5B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219A2F-EB09-F043-8E76-19115944F95F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8E6E3A10-8537-D299-21BB-7E3A1F989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4999D155-8CE9-A546-1090-FD94D1461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66F1417-5359-604A-AD64-FB1F9109806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05195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D86920CF-3EE8-59B6-64E6-9FDAF5D8E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8211BD-E46F-CE49-ACF8-5516AB758CB6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6F8AF49B-3C3F-4940-054E-EDB29C0EA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8F83BDC3-E996-F526-CF96-2B2297947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CC2A5ED-932D-4040-A246-7F5B585DFF3E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58826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FE222774-3A87-D63F-A20C-5507B93FA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877C3-EF13-D140-82DA-9E230E2A95F1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9E9F3D43-C566-2DA2-929B-2E3B392F7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ECF77B07-520E-B56B-4C16-37FA1D64A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FFDB7F2-8FE1-F84D-9A9B-12B9DDDBBAF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60995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5CA63E07-F66F-240F-06B0-01EDEAEF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820799-2DDF-7848-8F99-904B686D1A99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DCA4F36D-C24E-94BD-B3E5-E1663CE1A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59CCD8A0-AD7E-4E3B-9B45-33DD81163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523252D-D772-E249-8F09-AD5F018767BA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9423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4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3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1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EECBF17D-F44B-4B1C-59EB-52D802CEB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28765B-03BF-3E41-ACE8-EE97FEACCF65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156478CB-96D4-3D97-65B4-CEDF95C4B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B6E3B592-2502-8245-9658-F103A4BF3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8A2DF2E-EE04-0B43-853B-5EB629F58ECA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055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DF9DB815-0E28-A51E-AB9A-1CBB2E83E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8BA47F-A837-384B-8E5B-50580060483F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18E717FD-35D1-3417-25DF-84B6E4778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E19E7893-9446-2061-09E8-C45C47496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432F5B0-8D57-D040-A490-5D1B9FAE7B88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89099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4" indent="0">
              <a:buNone/>
              <a:defRPr sz="2000" b="1"/>
            </a:lvl2pPr>
            <a:lvl3pPr marL="914366" indent="0">
              <a:buNone/>
              <a:defRPr sz="1800" b="1"/>
            </a:lvl3pPr>
            <a:lvl4pPr marL="1371549" indent="0">
              <a:buNone/>
              <a:defRPr sz="1600" b="1"/>
            </a:lvl4pPr>
            <a:lvl5pPr marL="1828733" indent="0">
              <a:buNone/>
              <a:defRPr sz="1600" b="1"/>
            </a:lvl5pPr>
            <a:lvl6pPr marL="2285915" indent="0">
              <a:buNone/>
              <a:defRPr sz="1600" b="1"/>
            </a:lvl6pPr>
            <a:lvl7pPr marL="2743097" indent="0">
              <a:buNone/>
              <a:defRPr sz="1600" b="1"/>
            </a:lvl7pPr>
            <a:lvl8pPr marL="3200280" indent="0">
              <a:buNone/>
              <a:defRPr sz="1600" b="1"/>
            </a:lvl8pPr>
            <a:lvl9pPr marL="3657463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4" indent="0">
              <a:buNone/>
              <a:defRPr sz="2000" b="1"/>
            </a:lvl2pPr>
            <a:lvl3pPr marL="914366" indent="0">
              <a:buNone/>
              <a:defRPr sz="1800" b="1"/>
            </a:lvl3pPr>
            <a:lvl4pPr marL="1371549" indent="0">
              <a:buNone/>
              <a:defRPr sz="1600" b="1"/>
            </a:lvl4pPr>
            <a:lvl5pPr marL="1828733" indent="0">
              <a:buNone/>
              <a:defRPr sz="1600" b="1"/>
            </a:lvl5pPr>
            <a:lvl6pPr marL="2285915" indent="0">
              <a:buNone/>
              <a:defRPr sz="1600" b="1"/>
            </a:lvl6pPr>
            <a:lvl7pPr marL="2743097" indent="0">
              <a:buNone/>
              <a:defRPr sz="1600" b="1"/>
            </a:lvl7pPr>
            <a:lvl8pPr marL="3200280" indent="0">
              <a:buNone/>
              <a:defRPr sz="1600" b="1"/>
            </a:lvl8pPr>
            <a:lvl9pPr marL="3657463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3">
            <a:extLst>
              <a:ext uri="{FF2B5EF4-FFF2-40B4-BE49-F238E27FC236}">
                <a16:creationId xmlns:a16="http://schemas.microsoft.com/office/drawing/2014/main" id="{3D2412F9-8589-56A6-7755-8C4C3A716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546849-A6E4-854E-AB1B-B4A241196B76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8" name="フッター プレースホルダ 4">
            <a:extLst>
              <a:ext uri="{FF2B5EF4-FFF2-40B4-BE49-F238E27FC236}">
                <a16:creationId xmlns:a16="http://schemas.microsoft.com/office/drawing/2014/main" id="{41AB300A-BE74-7088-D6AF-08AD12893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>
            <a:extLst>
              <a:ext uri="{FF2B5EF4-FFF2-40B4-BE49-F238E27FC236}">
                <a16:creationId xmlns:a16="http://schemas.microsoft.com/office/drawing/2014/main" id="{13ED295C-1B87-F185-025F-2C3D9D9B1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4BD6993-455A-B649-A765-30B8DB879C2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73325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3">
            <a:extLst>
              <a:ext uri="{FF2B5EF4-FFF2-40B4-BE49-F238E27FC236}">
                <a16:creationId xmlns:a16="http://schemas.microsoft.com/office/drawing/2014/main" id="{DD4C3ACC-4A5F-CF85-C850-A51C2BAC4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119212-0321-B649-BA90-66CB48D20745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4" name="フッター プレースホルダ 4">
            <a:extLst>
              <a:ext uri="{FF2B5EF4-FFF2-40B4-BE49-F238E27FC236}">
                <a16:creationId xmlns:a16="http://schemas.microsoft.com/office/drawing/2014/main" id="{F8B86A57-A9BC-32BF-5E3B-B8226DC4F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>
            <a:extLst>
              <a:ext uri="{FF2B5EF4-FFF2-40B4-BE49-F238E27FC236}">
                <a16:creationId xmlns:a16="http://schemas.microsoft.com/office/drawing/2014/main" id="{2A9752AD-BB5D-213D-3356-2095EE8B5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0B5F83C-45D0-784E-B46F-E40F2777A7F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547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>
            <a:extLst>
              <a:ext uri="{FF2B5EF4-FFF2-40B4-BE49-F238E27FC236}">
                <a16:creationId xmlns:a16="http://schemas.microsoft.com/office/drawing/2014/main" id="{1B94F827-E612-0C42-0770-06829307F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A05C43-0A3F-ED44-B876-3536F9AFA50C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3" name="フッター プレースホルダ 4">
            <a:extLst>
              <a:ext uri="{FF2B5EF4-FFF2-40B4-BE49-F238E27FC236}">
                <a16:creationId xmlns:a16="http://schemas.microsoft.com/office/drawing/2014/main" id="{F448E1B1-8C46-BE8C-F237-83708DF99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>
            <a:extLst>
              <a:ext uri="{FF2B5EF4-FFF2-40B4-BE49-F238E27FC236}">
                <a16:creationId xmlns:a16="http://schemas.microsoft.com/office/drawing/2014/main" id="{886AB092-2525-F6F8-2D6E-8A4C05B9F3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4ABA7B7-569F-5640-A965-E43F1EF10A91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22193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2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4" indent="0">
              <a:buNone/>
              <a:defRPr sz="1200"/>
            </a:lvl2pPr>
            <a:lvl3pPr marL="914366" indent="0">
              <a:buNone/>
              <a:defRPr sz="1000"/>
            </a:lvl3pPr>
            <a:lvl4pPr marL="1371549" indent="0">
              <a:buNone/>
              <a:defRPr sz="900"/>
            </a:lvl4pPr>
            <a:lvl5pPr marL="1828733" indent="0">
              <a:buNone/>
              <a:defRPr sz="900"/>
            </a:lvl5pPr>
            <a:lvl6pPr marL="2285915" indent="0">
              <a:buNone/>
              <a:defRPr sz="900"/>
            </a:lvl6pPr>
            <a:lvl7pPr marL="2743097" indent="0">
              <a:buNone/>
              <a:defRPr sz="900"/>
            </a:lvl7pPr>
            <a:lvl8pPr marL="3200280" indent="0">
              <a:buNone/>
              <a:defRPr sz="900"/>
            </a:lvl8pPr>
            <a:lvl9pPr marL="3657463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7AD4D4B5-3AD0-FFA2-5CD9-7F72860B0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3E8C1F-5CD5-7C4F-B854-61FB9591E459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BA6AA1B8-E50B-29B0-89CB-EEB58C23C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FF4B94C7-B775-D704-C8D1-AFEE81476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C01F5B2-AFE2-8D4E-9943-D7B29C599D0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76507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4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84" indent="0">
              <a:buNone/>
              <a:defRPr sz="2800"/>
            </a:lvl2pPr>
            <a:lvl3pPr marL="914366" indent="0">
              <a:buNone/>
              <a:defRPr sz="2400"/>
            </a:lvl3pPr>
            <a:lvl4pPr marL="1371549" indent="0">
              <a:buNone/>
              <a:defRPr sz="2000"/>
            </a:lvl4pPr>
            <a:lvl5pPr marL="1828733" indent="0">
              <a:buNone/>
              <a:defRPr sz="2000"/>
            </a:lvl5pPr>
            <a:lvl6pPr marL="2285915" indent="0">
              <a:buNone/>
              <a:defRPr sz="2000"/>
            </a:lvl6pPr>
            <a:lvl7pPr marL="2743097" indent="0">
              <a:buNone/>
              <a:defRPr sz="2000"/>
            </a:lvl7pPr>
            <a:lvl8pPr marL="3200280" indent="0">
              <a:buNone/>
              <a:defRPr sz="2000"/>
            </a:lvl8pPr>
            <a:lvl9pPr marL="3657463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5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4" indent="0">
              <a:buNone/>
              <a:defRPr sz="1200"/>
            </a:lvl2pPr>
            <a:lvl3pPr marL="914366" indent="0">
              <a:buNone/>
              <a:defRPr sz="1000"/>
            </a:lvl3pPr>
            <a:lvl4pPr marL="1371549" indent="0">
              <a:buNone/>
              <a:defRPr sz="900"/>
            </a:lvl4pPr>
            <a:lvl5pPr marL="1828733" indent="0">
              <a:buNone/>
              <a:defRPr sz="900"/>
            </a:lvl5pPr>
            <a:lvl6pPr marL="2285915" indent="0">
              <a:buNone/>
              <a:defRPr sz="900"/>
            </a:lvl6pPr>
            <a:lvl7pPr marL="2743097" indent="0">
              <a:buNone/>
              <a:defRPr sz="900"/>
            </a:lvl7pPr>
            <a:lvl8pPr marL="3200280" indent="0">
              <a:buNone/>
              <a:defRPr sz="900"/>
            </a:lvl8pPr>
            <a:lvl9pPr marL="3657463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>
            <a:extLst>
              <a:ext uri="{FF2B5EF4-FFF2-40B4-BE49-F238E27FC236}">
                <a16:creationId xmlns:a16="http://schemas.microsoft.com/office/drawing/2014/main" id="{31A7F5CC-2129-5B1B-DBEA-4B1CC1AAD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9BFE87-0C39-5949-895A-3D0EAB283F3B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6" name="フッター プレースホルダ 4">
            <a:extLst>
              <a:ext uri="{FF2B5EF4-FFF2-40B4-BE49-F238E27FC236}">
                <a16:creationId xmlns:a16="http://schemas.microsoft.com/office/drawing/2014/main" id="{0C8C8A63-CA54-BA75-AA7D-67E500252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>
            <a:extLst>
              <a:ext uri="{FF2B5EF4-FFF2-40B4-BE49-F238E27FC236}">
                <a16:creationId xmlns:a16="http://schemas.microsoft.com/office/drawing/2014/main" id="{A9B83963-D040-48C9-121C-2E8891CBF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689477-D0B8-C349-BE68-F5B4BB62CAD1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64551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>
            <a:extLst>
              <a:ext uri="{FF2B5EF4-FFF2-40B4-BE49-F238E27FC236}">
                <a16:creationId xmlns:a16="http://schemas.microsoft.com/office/drawing/2014/main" id="{7A4D1483-A154-C2C9-0FF2-5007C547C67E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>
            <a:extLst>
              <a:ext uri="{FF2B5EF4-FFF2-40B4-BE49-F238E27FC236}">
                <a16:creationId xmlns:a16="http://schemas.microsoft.com/office/drawing/2014/main" id="{D473E353-362C-9904-6A25-C262CBFD8EE6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>
            <a:extLst>
              <a:ext uri="{FF2B5EF4-FFF2-40B4-BE49-F238E27FC236}">
                <a16:creationId xmlns:a16="http://schemas.microsoft.com/office/drawing/2014/main" id="{BC40F7B0-40DD-8447-9E81-C39178B680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6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FFC7D1D-B531-8F4B-BFD8-FBE22D1564D6}" type="datetimeFigureOut">
              <a:rPr lang="ja-JP" altLang="en-US"/>
              <a:pPr>
                <a:defRPr/>
              </a:pPr>
              <a:t>2025/12/15</a:t>
            </a:fld>
            <a:endParaRPr lang="ja-JP" altLang="en-US"/>
          </a:p>
        </p:txBody>
      </p:sp>
      <p:sp>
        <p:nvSpPr>
          <p:cNvPr id="5" name="フッター プレースホルダ 4">
            <a:extLst>
              <a:ext uri="{FF2B5EF4-FFF2-40B4-BE49-F238E27FC236}">
                <a16:creationId xmlns:a16="http://schemas.microsoft.com/office/drawing/2014/main" id="{26A7701D-D700-B749-B85F-F1E8D84772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6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>
            <a:extLst>
              <a:ext uri="{FF2B5EF4-FFF2-40B4-BE49-F238E27FC236}">
                <a16:creationId xmlns:a16="http://schemas.microsoft.com/office/drawing/2014/main" id="{645FCB33-01F7-6245-83E3-0E6074F8CB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6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290A1B8C-98FD-2B44-ADFD-2AA00E1829E0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panose="020B0600070205080204" pitchFamily="34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5pPr>
      <a:lvl6pPr marL="457184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6pPr>
      <a:lvl7pPr marL="914366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7pPr>
      <a:lvl8pPr marL="1371549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8pPr>
      <a:lvl9pPr marL="1828733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  <a:cs typeface="ＭＳ Ｐゴシック" panose="020B0600070205080204" pitchFamily="34" charset="-128"/>
        </a:defRPr>
      </a:lvl9pPr>
    </p:titleStyle>
    <p:bodyStyle>
      <a:lvl1pPr marL="342884" indent="-34288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1pPr>
      <a:lvl2pPr marL="742913" indent="-285736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2pPr>
      <a:lvl3pPr marL="1142944" indent="-228588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3pPr>
      <a:lvl4pPr marL="1600120" indent="-228588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4pPr>
      <a:lvl5pPr marL="2057297" indent="-228588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ＭＳ Ｐゴシック" panose="020B0600070205080204" pitchFamily="34" charset="-128"/>
        </a:defRPr>
      </a:lvl5pPr>
      <a:lvl6pPr marL="2514506" indent="-228591" algn="l" defTabSz="91436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9" indent="-228591" algn="l" defTabSz="91436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71" indent="-228591" algn="l" defTabSz="91436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54" indent="-228591" algn="l" defTabSz="914366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4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6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9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33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15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7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80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63" algn="l" defTabSz="914366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B2845E6-63DB-C5F0-A163-BF5455F3F7CA}"/>
              </a:ext>
            </a:extLst>
          </p:cNvPr>
          <p:cNvSpPr txBox="1"/>
          <p:nvPr/>
        </p:nvSpPr>
        <p:spPr>
          <a:xfrm>
            <a:off x="484189" y="2300715"/>
            <a:ext cx="5603875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Stage II-IV rectal cancer treated with preoperative chemoradiotherapy</a:t>
            </a:r>
          </a:p>
          <a:p>
            <a:pPr algn="ctr"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April 2005-March 2023, n = 378)</a:t>
            </a: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78700582-07F7-FAAE-920D-63D1191DCE37}"/>
              </a:ext>
            </a:extLst>
          </p:cNvPr>
          <p:cNvCxnSpPr>
            <a:cxnSpLocks/>
          </p:cNvCxnSpPr>
          <p:nvPr/>
        </p:nvCxnSpPr>
        <p:spPr>
          <a:xfrm rot="16200000" flipH="1">
            <a:off x="2812257" y="2661445"/>
            <a:ext cx="0" cy="10810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EAA0E4E-0BA4-4E80-7322-31C3DDAA3B94}"/>
              </a:ext>
            </a:extLst>
          </p:cNvPr>
          <p:cNvSpPr txBox="1"/>
          <p:nvPr/>
        </p:nvSpPr>
        <p:spPr>
          <a:xfrm>
            <a:off x="3351058" y="2994024"/>
            <a:ext cx="2737005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tage IV disease</a:t>
            </a:r>
          </a:p>
          <a:p>
            <a:pPr algn="ctr">
              <a:defRPr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n = 20)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5588635-3F6F-6AA8-5F9E-C169E48606E7}"/>
              </a:ext>
            </a:extLst>
          </p:cNvPr>
          <p:cNvSpPr txBox="1"/>
          <p:nvPr/>
        </p:nvSpPr>
        <p:spPr>
          <a:xfrm>
            <a:off x="3351058" y="4215424"/>
            <a:ext cx="2735263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istant metastasis during preoperative chemoradiotherapy</a:t>
            </a:r>
          </a:p>
          <a:p>
            <a:pPr algn="ctr">
              <a:defRPr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n = 9)</a:t>
            </a: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22EACC76-3713-5338-2B18-61615AA9BA04}"/>
              </a:ext>
            </a:extLst>
          </p:cNvPr>
          <p:cNvCxnSpPr>
            <a:cxnSpLocks/>
          </p:cNvCxnSpPr>
          <p:nvPr/>
        </p:nvCxnSpPr>
        <p:spPr>
          <a:xfrm rot="16200000" flipH="1">
            <a:off x="2810515" y="3329466"/>
            <a:ext cx="0" cy="10810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EBD12B1D-DFAA-3293-4AF5-E9A94E763F46}"/>
              </a:ext>
            </a:extLst>
          </p:cNvPr>
          <p:cNvCxnSpPr>
            <a:cxnSpLocks/>
          </p:cNvCxnSpPr>
          <p:nvPr/>
        </p:nvCxnSpPr>
        <p:spPr>
          <a:xfrm>
            <a:off x="2271713" y="2716214"/>
            <a:ext cx="0" cy="286389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7DD81272-D8AD-55E2-FA7F-C9DF7E3DB986}"/>
              </a:ext>
            </a:extLst>
          </p:cNvPr>
          <p:cNvCxnSpPr>
            <a:cxnSpLocks/>
          </p:cNvCxnSpPr>
          <p:nvPr/>
        </p:nvCxnSpPr>
        <p:spPr>
          <a:xfrm rot="16200000" flipH="1">
            <a:off x="2812257" y="3959449"/>
            <a:ext cx="0" cy="10810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A18B411-24AE-F43F-ACD1-AFE283253980}"/>
              </a:ext>
            </a:extLst>
          </p:cNvPr>
          <p:cNvSpPr txBox="1"/>
          <p:nvPr/>
        </p:nvSpPr>
        <p:spPr>
          <a:xfrm>
            <a:off x="1305719" y="5591753"/>
            <a:ext cx="1931987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Selected patients</a:t>
            </a:r>
          </a:p>
          <a:p>
            <a:pPr algn="ctr"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n = 343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4165009-9F89-5BA5-65AD-A930BD9D2B8E}"/>
              </a:ext>
            </a:extLst>
          </p:cNvPr>
          <p:cNvSpPr txBox="1"/>
          <p:nvPr/>
        </p:nvSpPr>
        <p:spPr>
          <a:xfrm>
            <a:off x="3351058" y="3527129"/>
            <a:ext cx="2735263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   Only rectal resection without metastatic organ resection   </a:t>
            </a:r>
          </a:p>
          <a:p>
            <a:pPr algn="ctr"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n = 4)</a:t>
            </a:r>
          </a:p>
        </p:txBody>
      </p:sp>
      <p:sp>
        <p:nvSpPr>
          <p:cNvPr id="2" name="テキスト ボックス 4">
            <a:extLst>
              <a:ext uri="{FF2B5EF4-FFF2-40B4-BE49-F238E27FC236}">
                <a16:creationId xmlns:a16="http://schemas.microsoft.com/office/drawing/2014/main" id="{94095E5E-8DD8-834B-7402-05FF846239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2" y="1691680"/>
            <a:ext cx="38025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E586C3F3-1F03-6DB0-01DB-0B71C7E556A4}"/>
              </a:ext>
            </a:extLst>
          </p:cNvPr>
          <p:cNvCxnSpPr>
            <a:cxnSpLocks/>
          </p:cNvCxnSpPr>
          <p:nvPr/>
        </p:nvCxnSpPr>
        <p:spPr>
          <a:xfrm rot="16200000" flipH="1">
            <a:off x="2818453" y="4607521"/>
            <a:ext cx="0" cy="10810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46D1B99-47E8-A790-FE96-7A21D46EDAC2}"/>
              </a:ext>
            </a:extLst>
          </p:cNvPr>
          <p:cNvSpPr txBox="1"/>
          <p:nvPr/>
        </p:nvSpPr>
        <p:spPr>
          <a:xfrm>
            <a:off x="3358996" y="4944795"/>
            <a:ext cx="2735263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Non-operative management</a:t>
            </a:r>
          </a:p>
          <a:p>
            <a:pPr algn="ctr">
              <a:defRPr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n = 2)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19EB134-F692-0981-78DF-6C056ABB17F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60" name="テキスト ボックス 4">
            <a:extLst>
              <a:ext uri="{FF2B5EF4-FFF2-40B4-BE49-F238E27FC236}">
                <a16:creationId xmlns:a16="http://schemas.microsoft.com/office/drawing/2014/main" id="{7B0CFF60-25A1-1039-1887-ADA23A640D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2" y="128588"/>
            <a:ext cx="38025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61" name="テキスト ボックス 5">
            <a:extLst>
              <a:ext uri="{FF2B5EF4-FFF2-40B4-BE49-F238E27FC236}">
                <a16:creationId xmlns:a16="http://schemas.microsoft.com/office/drawing/2014/main" id="{D4BA5DED-AEBC-02C9-75D5-506B17FE00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75" y="423863"/>
            <a:ext cx="59207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 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ercentage of cases under the median of PMI loss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62" name="テキスト ボックス 2">
            <a:extLst>
              <a:ext uri="{FF2B5EF4-FFF2-40B4-BE49-F238E27FC236}">
                <a16:creationId xmlns:a16="http://schemas.microsoft.com/office/drawing/2014/main" id="{8243EEFA-10E2-CC9B-D4BE-A880062FA3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2928253"/>
            <a:ext cx="53367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rcentage of cases under the median of VFI loss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69" name="テキスト ボックス 53">
            <a:extLst>
              <a:ext uri="{FF2B5EF4-FFF2-40B4-BE49-F238E27FC236}">
                <a16:creationId xmlns:a16="http://schemas.microsoft.com/office/drawing/2014/main" id="{54C70D2C-5E91-FAF4-353D-73C5A6C3FD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5526617"/>
            <a:ext cx="50851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rcentage of cases under the median of SFI loss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57">
            <a:extLst>
              <a:ext uri="{FF2B5EF4-FFF2-40B4-BE49-F238E27FC236}">
                <a16:creationId xmlns:a16="http://schemas.microsoft.com/office/drawing/2014/main" id="{664B027E-7B8D-D07A-56FF-1C7E9B5D73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7285" y="753747"/>
            <a:ext cx="10951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0.402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57">
            <a:extLst>
              <a:ext uri="{FF2B5EF4-FFF2-40B4-BE49-F238E27FC236}">
                <a16:creationId xmlns:a16="http://schemas.microsoft.com/office/drawing/2014/main" id="{42F558A1-EC34-611E-B41B-B81A16E9BC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8618" y="3203848"/>
            <a:ext cx="10951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&lt; 0.001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57">
            <a:extLst>
              <a:ext uri="{FF2B5EF4-FFF2-40B4-BE49-F238E27FC236}">
                <a16:creationId xmlns:a16="http://schemas.microsoft.com/office/drawing/2014/main" id="{1532E1F9-F9D3-ED4C-F964-D3B6A2F1F4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7286" y="5879177"/>
            <a:ext cx="10951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&lt; 0.001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FA932039-28F7-1FE3-1261-3D5FFC4874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1934057"/>
              </p:ext>
            </p:extLst>
          </p:nvPr>
        </p:nvGraphicFramePr>
        <p:xfrm>
          <a:off x="440997" y="884724"/>
          <a:ext cx="4572000" cy="21225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0D4A51F8-A52A-5447-8EF1-715E830EE1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0402919"/>
              </p:ext>
            </p:extLst>
          </p:nvPr>
        </p:nvGraphicFramePr>
        <p:xfrm>
          <a:off x="453731" y="3347852"/>
          <a:ext cx="4552482" cy="21225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873232E5-7693-4047-BD8E-6F10E6E361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2393715"/>
              </p:ext>
            </p:extLst>
          </p:nvPr>
        </p:nvGraphicFramePr>
        <p:xfrm>
          <a:off x="453731" y="6012159"/>
          <a:ext cx="4559266" cy="21225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57">
            <a:extLst>
              <a:ext uri="{FF2B5EF4-FFF2-40B4-BE49-F238E27FC236}">
                <a16:creationId xmlns:a16="http://schemas.microsoft.com/office/drawing/2014/main" id="{4EFB84BF-F129-D3A3-6D22-5F322A1317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663" y="694988"/>
            <a:ext cx="4470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%)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57">
            <a:extLst>
              <a:ext uri="{FF2B5EF4-FFF2-40B4-BE49-F238E27FC236}">
                <a16:creationId xmlns:a16="http://schemas.microsoft.com/office/drawing/2014/main" id="{7252700D-A8F0-E1FA-C7C2-DA244D53BE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663" y="3131840"/>
            <a:ext cx="4470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%)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57">
            <a:extLst>
              <a:ext uri="{FF2B5EF4-FFF2-40B4-BE49-F238E27FC236}">
                <a16:creationId xmlns:a16="http://schemas.microsoft.com/office/drawing/2014/main" id="{0BC376BA-70C0-C472-58B6-95A834E272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663" y="5797742"/>
            <a:ext cx="4470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%)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73707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153F5F-78DA-BE45-B50F-6C12ED1B6E5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8" name="図 21507">
            <a:extLst>
              <a:ext uri="{FF2B5EF4-FFF2-40B4-BE49-F238E27FC236}">
                <a16:creationId xmlns:a16="http://schemas.microsoft.com/office/drawing/2014/main" id="{92E23CEA-B23A-918F-E616-43043D7414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9970" y="398430"/>
            <a:ext cx="2802600" cy="1911600"/>
          </a:xfrm>
          <a:prstGeom prst="rect">
            <a:avLst/>
          </a:prstGeom>
        </p:spPr>
      </p:pic>
      <p:pic>
        <p:nvPicPr>
          <p:cNvPr id="21507" name="図 21506">
            <a:extLst>
              <a:ext uri="{FF2B5EF4-FFF2-40B4-BE49-F238E27FC236}">
                <a16:creationId xmlns:a16="http://schemas.microsoft.com/office/drawing/2014/main" id="{BE3681D0-13E3-4680-6B4B-980979810B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5714" y="401380"/>
            <a:ext cx="2802600" cy="1911600"/>
          </a:xfrm>
          <a:prstGeom prst="rect">
            <a:avLst/>
          </a:prstGeom>
        </p:spPr>
      </p:pic>
      <p:pic>
        <p:nvPicPr>
          <p:cNvPr id="21506" name="図 21505">
            <a:extLst>
              <a:ext uri="{FF2B5EF4-FFF2-40B4-BE49-F238E27FC236}">
                <a16:creationId xmlns:a16="http://schemas.microsoft.com/office/drawing/2014/main" id="{006C044E-E501-71D6-9A57-BBF8418640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8426" y="3419993"/>
            <a:ext cx="2802600" cy="1911600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8C442377-E6EF-8915-4F66-B59FC1DB7D5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1983" y="3419993"/>
            <a:ext cx="2802600" cy="1911600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79784B64-E987-4113-B88B-09A8A11DC6E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8426" y="6375701"/>
            <a:ext cx="2802600" cy="1911600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8096389D-12E9-CA48-5137-7E880666599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0376" y="6355816"/>
            <a:ext cx="2802600" cy="1911600"/>
          </a:xfrm>
          <a:prstGeom prst="rect">
            <a:avLst/>
          </a:prstGeom>
        </p:spPr>
      </p:pic>
      <p:sp>
        <p:nvSpPr>
          <p:cNvPr id="21509" name="テキスト ボックス 4">
            <a:extLst>
              <a:ext uri="{FF2B5EF4-FFF2-40B4-BE49-F238E27FC236}">
                <a16:creationId xmlns:a16="http://schemas.microsoft.com/office/drawing/2014/main" id="{35B189F6-00BA-ABAD-029D-5A22049843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85" y="-36512"/>
            <a:ext cx="21685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3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99">
            <a:extLst>
              <a:ext uri="{FF2B5EF4-FFF2-40B4-BE49-F238E27FC236}">
                <a16:creationId xmlns:a16="http://schemas.microsoft.com/office/drawing/2014/main" id="{95B4B803-241B-31CD-5B43-F02E87C132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492" y="154653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 2005-2011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55">
            <a:extLst>
              <a:ext uri="{FF2B5EF4-FFF2-40B4-BE49-F238E27FC236}">
                <a16:creationId xmlns:a16="http://schemas.microsoft.com/office/drawing/2014/main" id="{3647492A-849A-9CBB-494E-99F431E771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0848" y="1653788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= 0.011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57">
            <a:extLst>
              <a:ext uri="{FF2B5EF4-FFF2-40B4-BE49-F238E27FC236}">
                <a16:creationId xmlns:a16="http://schemas.microsoft.com/office/drawing/2014/main" id="{09EA7108-921C-846D-7D24-2A2F04FAFD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7318" y="2051720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58">
            <a:extLst>
              <a:ext uri="{FF2B5EF4-FFF2-40B4-BE49-F238E27FC236}">
                <a16:creationId xmlns:a16="http://schemas.microsoft.com/office/drawing/2014/main" id="{CA2E772E-5C4C-7F55-7527-BD00C0A64564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254888" y="1078541"/>
            <a:ext cx="14972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verall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65">
            <a:extLst>
              <a:ext uri="{FF2B5EF4-FFF2-40B4-BE49-F238E27FC236}">
                <a16:creationId xmlns:a16="http://schemas.microsoft.com/office/drawing/2014/main" id="{7B145504-4D84-E07C-6C7D-E8D86E5A9A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261" y="2198456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  7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75       73       63       52       41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 11       11         7         6         6         5</a:t>
            </a:r>
          </a:p>
        </p:txBody>
      </p:sp>
      <p:sp>
        <p:nvSpPr>
          <p:cNvPr id="42" name="テキスト ボックス 59">
            <a:extLst>
              <a:ext uri="{FF2B5EF4-FFF2-40B4-BE49-F238E27FC236}">
                <a16:creationId xmlns:a16="http://schemas.microsoft.com/office/drawing/2014/main" id="{08AAF2FE-DF9A-2CA6-DB03-498049594B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0034" y="410818"/>
            <a:ext cx="231933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43" name="テキスト ボックス 61">
            <a:extLst>
              <a:ext uri="{FF2B5EF4-FFF2-40B4-BE49-F238E27FC236}">
                <a16:creationId xmlns:a16="http://schemas.microsoft.com/office/drawing/2014/main" id="{702A3E99-4599-BDAE-0991-63B5A256A3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5333" y="1096439"/>
            <a:ext cx="23463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  <p:sp>
        <p:nvSpPr>
          <p:cNvPr id="53" name="テキスト ボックス 99">
            <a:extLst>
              <a:ext uri="{FF2B5EF4-FFF2-40B4-BE49-F238E27FC236}">
                <a16:creationId xmlns:a16="http://schemas.microsoft.com/office/drawing/2014/main" id="{C5F1E8D9-D747-DE8A-437F-2BD9DC2BF8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492" y="3192797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 2012-2017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5">
            <a:extLst>
              <a:ext uri="{FF2B5EF4-FFF2-40B4-BE49-F238E27FC236}">
                <a16:creationId xmlns:a16="http://schemas.microsoft.com/office/drawing/2014/main" id="{61D0326F-0E6A-CF0F-CABD-9B2C96C0A3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3216" y="1653788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= 0.563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8">
            <a:extLst>
              <a:ext uri="{FF2B5EF4-FFF2-40B4-BE49-F238E27FC236}">
                <a16:creationId xmlns:a16="http://schemas.microsoft.com/office/drawing/2014/main" id="{1705A63B-B413-18F0-96A8-E2D2746279EE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820866" y="1080624"/>
            <a:ext cx="191212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5">
            <a:extLst>
              <a:ext uri="{FF2B5EF4-FFF2-40B4-BE49-F238E27FC236}">
                <a16:creationId xmlns:a16="http://schemas.microsoft.com/office/drawing/2014/main" id="{2267E98A-464E-8891-365F-4DDD5A277F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3566" y="2195736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  7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74       73       63       52       41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 11       11         7         6         6         5</a:t>
            </a:r>
          </a:p>
        </p:txBody>
      </p:sp>
      <p:sp>
        <p:nvSpPr>
          <p:cNvPr id="21504" name="テキスト ボックス 59">
            <a:extLst>
              <a:ext uri="{FF2B5EF4-FFF2-40B4-BE49-F238E27FC236}">
                <a16:creationId xmlns:a16="http://schemas.microsoft.com/office/drawing/2014/main" id="{EF2F0ECC-4E07-4FC9-FFBE-E545DD53D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0674" y="655381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21505" name="テキスト ボックス 61">
            <a:extLst>
              <a:ext uri="{FF2B5EF4-FFF2-40B4-BE49-F238E27FC236}">
                <a16:creationId xmlns:a16="http://schemas.microsoft.com/office/drawing/2014/main" id="{F97D197F-2CFE-CAC5-E0C7-6BD2E361CA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0674" y="1066473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  <p:sp>
        <p:nvSpPr>
          <p:cNvPr id="11" name="テキスト ボックス 57">
            <a:extLst>
              <a:ext uri="{FF2B5EF4-FFF2-40B4-BE49-F238E27FC236}">
                <a16:creationId xmlns:a16="http://schemas.microsoft.com/office/drawing/2014/main" id="{B6048069-0A46-D32E-9518-0E7004E69F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33651" y="2051720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99">
            <a:extLst>
              <a:ext uri="{FF2B5EF4-FFF2-40B4-BE49-F238E27FC236}">
                <a16:creationId xmlns:a16="http://schemas.microsoft.com/office/drawing/2014/main" id="{559B6164-BD83-2BBA-49E5-7F8964EDB0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3666" y="151788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 2005-2011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99">
            <a:extLst>
              <a:ext uri="{FF2B5EF4-FFF2-40B4-BE49-F238E27FC236}">
                <a16:creationId xmlns:a16="http://schemas.microsoft.com/office/drawing/2014/main" id="{2A75D6AF-65FF-DFBA-BDE0-C12F067783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5264" y="3192796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 2012-2017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55">
            <a:extLst>
              <a:ext uri="{FF2B5EF4-FFF2-40B4-BE49-F238E27FC236}">
                <a16:creationId xmlns:a16="http://schemas.microsoft.com/office/drawing/2014/main" id="{C583372D-94B0-5FB4-C18E-73B980398B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3216" y="4711680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= 0.015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58">
            <a:extLst>
              <a:ext uri="{FF2B5EF4-FFF2-40B4-BE49-F238E27FC236}">
                <a16:creationId xmlns:a16="http://schemas.microsoft.com/office/drawing/2014/main" id="{93B75696-030C-451F-7A51-45CC62149916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815920" y="4092105"/>
            <a:ext cx="191212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65">
            <a:extLst>
              <a:ext uri="{FF2B5EF4-FFF2-40B4-BE49-F238E27FC236}">
                <a16:creationId xmlns:a16="http://schemas.microsoft.com/office/drawing/2014/main" id="{CBB613BB-8C96-334D-0254-3A96315007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8620" y="5191173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 144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105     91       53      28       5 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  22        14     10         7        3          </a:t>
            </a:r>
          </a:p>
        </p:txBody>
      </p:sp>
      <p:sp>
        <p:nvSpPr>
          <p:cNvPr id="18" name="テキスト ボックス 59">
            <a:extLst>
              <a:ext uri="{FF2B5EF4-FFF2-40B4-BE49-F238E27FC236}">
                <a16:creationId xmlns:a16="http://schemas.microsoft.com/office/drawing/2014/main" id="{DAC2C0D5-783A-762E-8CFF-D814C5B6B1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7215" y="3733069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19" name="テキスト ボックス 61">
            <a:extLst>
              <a:ext uri="{FF2B5EF4-FFF2-40B4-BE49-F238E27FC236}">
                <a16:creationId xmlns:a16="http://schemas.microsoft.com/office/drawing/2014/main" id="{D75FA9A4-EF18-98DD-C26B-A4F74C7980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0644" y="4427984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  <p:sp>
        <p:nvSpPr>
          <p:cNvPr id="20" name="テキスト ボックス 57">
            <a:extLst>
              <a:ext uri="{FF2B5EF4-FFF2-40B4-BE49-F238E27FC236}">
                <a16:creationId xmlns:a16="http://schemas.microsoft.com/office/drawing/2014/main" id="{CC2D4A6A-DEBB-9FD8-ACC8-91A94E2749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8705" y="5065530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99">
            <a:extLst>
              <a:ext uri="{FF2B5EF4-FFF2-40B4-BE49-F238E27FC236}">
                <a16:creationId xmlns:a16="http://schemas.microsoft.com/office/drawing/2014/main" id="{8EEBBE55-528E-396E-F9BE-C5124B2B7A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0318" y="6156278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 2018-2023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55">
            <a:extLst>
              <a:ext uri="{FF2B5EF4-FFF2-40B4-BE49-F238E27FC236}">
                <a16:creationId xmlns:a16="http://schemas.microsoft.com/office/drawing/2014/main" id="{720B05A2-B965-DD8D-AE0B-10E36F5081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9351" y="4704964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= 0.002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57">
            <a:extLst>
              <a:ext uri="{FF2B5EF4-FFF2-40B4-BE49-F238E27FC236}">
                <a16:creationId xmlns:a16="http://schemas.microsoft.com/office/drawing/2014/main" id="{CC6EF81A-382B-F52C-1B26-A667885BAE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7705" y="5065004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58">
            <a:extLst>
              <a:ext uri="{FF2B5EF4-FFF2-40B4-BE49-F238E27FC236}">
                <a16:creationId xmlns:a16="http://schemas.microsoft.com/office/drawing/2014/main" id="{394AC266-012E-D04E-170F-0E09D4446376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184501" y="4108650"/>
            <a:ext cx="14972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verall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65">
            <a:extLst>
              <a:ext uri="{FF2B5EF4-FFF2-40B4-BE49-F238E27FC236}">
                <a16:creationId xmlns:a16="http://schemas.microsoft.com/office/drawing/2014/main" id="{568D4364-2F67-30DC-33A7-D89B1A08A4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648" y="5212521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 144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105     91       53      28       5 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  22        14     10         7        3          </a:t>
            </a:r>
          </a:p>
        </p:txBody>
      </p:sp>
      <p:sp>
        <p:nvSpPr>
          <p:cNvPr id="26" name="テキスト ボックス 59">
            <a:extLst>
              <a:ext uri="{FF2B5EF4-FFF2-40B4-BE49-F238E27FC236}">
                <a16:creationId xmlns:a16="http://schemas.microsoft.com/office/drawing/2014/main" id="{C5179E5D-8FFE-339F-16CF-C6819B079E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2320" y="3433413"/>
            <a:ext cx="231933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27" name="テキスト ボックス 61">
            <a:extLst>
              <a:ext uri="{FF2B5EF4-FFF2-40B4-BE49-F238E27FC236}">
                <a16:creationId xmlns:a16="http://schemas.microsoft.com/office/drawing/2014/main" id="{58AF4854-5029-B3E1-16A1-A355B65852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2668" y="4166948"/>
            <a:ext cx="23463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  <p:sp>
        <p:nvSpPr>
          <p:cNvPr id="28" name="テキスト ボックス 99">
            <a:extLst>
              <a:ext uri="{FF2B5EF4-FFF2-40B4-BE49-F238E27FC236}">
                <a16:creationId xmlns:a16="http://schemas.microsoft.com/office/drawing/2014/main" id="{4D6C3D8E-D8B2-E9B6-FC55-3DA5FDD9B6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492" y="6156176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 2018-2023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55">
            <a:extLst>
              <a:ext uri="{FF2B5EF4-FFF2-40B4-BE49-F238E27FC236}">
                <a16:creationId xmlns:a16="http://schemas.microsoft.com/office/drawing/2014/main" id="{F6F709A0-F40A-8772-7418-216A07736B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3216" y="7668344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= 0.152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58">
            <a:extLst>
              <a:ext uri="{FF2B5EF4-FFF2-40B4-BE49-F238E27FC236}">
                <a16:creationId xmlns:a16="http://schemas.microsoft.com/office/drawing/2014/main" id="{77B54ABC-0D70-0951-445C-BEF6DEB7409F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815920" y="7038577"/>
            <a:ext cx="191212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59">
            <a:extLst>
              <a:ext uri="{FF2B5EF4-FFF2-40B4-BE49-F238E27FC236}">
                <a16:creationId xmlns:a16="http://schemas.microsoft.com/office/drawing/2014/main" id="{1BAAEC3C-C5CB-F66B-E443-F25E11814A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9796" y="6468707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39" name="テキスト ボックス 61">
            <a:extLst>
              <a:ext uri="{FF2B5EF4-FFF2-40B4-BE49-F238E27FC236}">
                <a16:creationId xmlns:a16="http://schemas.microsoft.com/office/drawing/2014/main" id="{514F3125-494B-5DD6-EA61-D64510B113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8014" y="7244293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  <p:sp>
        <p:nvSpPr>
          <p:cNvPr id="40" name="テキスト ボックス 57">
            <a:extLst>
              <a:ext uri="{FF2B5EF4-FFF2-40B4-BE49-F238E27FC236}">
                <a16:creationId xmlns:a16="http://schemas.microsoft.com/office/drawing/2014/main" id="{5051D42C-30F5-7494-D300-F463BEF853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8705" y="8074456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65">
            <a:extLst>
              <a:ext uri="{FF2B5EF4-FFF2-40B4-BE49-F238E27FC236}">
                <a16:creationId xmlns:a16="http://schemas.microsoft.com/office/drawing/2014/main" id="{77E5CA32-27B8-352D-F240-2EF06AF9D4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2918" y="8131683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 11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87       50         5    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2     10       </a:t>
            </a:r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       </a:t>
            </a:r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5" name="テキスト ボックス 55">
            <a:extLst>
              <a:ext uri="{FF2B5EF4-FFF2-40B4-BE49-F238E27FC236}">
                <a16:creationId xmlns:a16="http://schemas.microsoft.com/office/drawing/2014/main" id="{65708C2A-F9B2-7D30-2A20-6ACFBBA0CC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9351" y="7630452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= 0.589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57">
            <a:extLst>
              <a:ext uri="{FF2B5EF4-FFF2-40B4-BE49-F238E27FC236}">
                <a16:creationId xmlns:a16="http://schemas.microsoft.com/office/drawing/2014/main" id="{FA463A00-AFFD-84EB-B5AB-D5E8D8BA1A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7705" y="8016489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58">
            <a:extLst>
              <a:ext uri="{FF2B5EF4-FFF2-40B4-BE49-F238E27FC236}">
                <a16:creationId xmlns:a16="http://schemas.microsoft.com/office/drawing/2014/main" id="{7C62C53B-AF7E-CB32-EFC7-C64964277AB6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184501" y="6997681"/>
            <a:ext cx="14972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verall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65">
            <a:extLst>
              <a:ext uri="{FF2B5EF4-FFF2-40B4-BE49-F238E27FC236}">
                <a16:creationId xmlns:a16="http://schemas.microsoft.com/office/drawing/2014/main" id="{85C2361A-4C5C-8A14-FC00-90C9C07E04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648" y="8164006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 11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87       50         5    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2     10       </a:t>
            </a:r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       </a:t>
            </a:r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9" name="テキスト ボックス 59">
            <a:extLst>
              <a:ext uri="{FF2B5EF4-FFF2-40B4-BE49-F238E27FC236}">
                <a16:creationId xmlns:a16="http://schemas.microsoft.com/office/drawing/2014/main" id="{E5F39F44-8B39-4CE8-AB31-692948ADFB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9863" y="6253410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50" name="テキスト ボックス 61">
            <a:extLst>
              <a:ext uri="{FF2B5EF4-FFF2-40B4-BE49-F238E27FC236}">
                <a16:creationId xmlns:a16="http://schemas.microsoft.com/office/drawing/2014/main" id="{6D97A553-1864-F022-41E6-35D1913D8D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8210" y="6648216"/>
            <a:ext cx="142565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</p:spTree>
    <p:extLst>
      <p:ext uri="{BB962C8B-B14F-4D97-AF65-F5344CB8AC3E}">
        <p14:creationId xmlns:p14="http://schemas.microsoft.com/office/powerpoint/2010/main" val="26309473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2B4CB69-283F-D918-6F91-C4A9401914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204" y="1180639"/>
            <a:ext cx="3166780" cy="216000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99BF5790-AB4F-7F70-6E43-45592B5473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33999" y="1182687"/>
            <a:ext cx="3166780" cy="2160000"/>
          </a:xfrm>
          <a:prstGeom prst="rect">
            <a:avLst/>
          </a:prstGeom>
        </p:spPr>
      </p:pic>
      <p:sp>
        <p:nvSpPr>
          <p:cNvPr id="21509" name="テキスト ボックス 4">
            <a:extLst>
              <a:ext uri="{FF2B5EF4-FFF2-40B4-BE49-F238E27FC236}">
                <a16:creationId xmlns:a16="http://schemas.microsoft.com/office/drawing/2014/main" id="{D1B97550-F10A-288B-5534-27C5E19276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3" y="128588"/>
            <a:ext cx="21685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4 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5">
            <a:extLst>
              <a:ext uri="{FF2B5EF4-FFF2-40B4-BE49-F238E27FC236}">
                <a16:creationId xmlns:a16="http://schemas.microsoft.com/office/drawing/2014/main" id="{FB6A4107-52F7-728E-BE43-3CAEBEC36D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75" y="423863"/>
            <a:ext cx="485933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ody weight loss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99">
            <a:extLst>
              <a:ext uri="{FF2B5EF4-FFF2-40B4-BE49-F238E27FC236}">
                <a16:creationId xmlns:a16="http://schemas.microsoft.com/office/drawing/2014/main" id="{C0161188-908A-3526-4029-BFBB9F1987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888" y="692150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55">
            <a:extLst>
              <a:ext uri="{FF2B5EF4-FFF2-40B4-BE49-F238E27FC236}">
                <a16:creationId xmlns:a16="http://schemas.microsoft.com/office/drawing/2014/main" id="{F0EEFAFE-A561-0B81-6645-F95047DE66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2857" y="2661901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57">
            <a:extLst>
              <a:ext uri="{FF2B5EF4-FFF2-40B4-BE49-F238E27FC236}">
                <a16:creationId xmlns:a16="http://schemas.microsoft.com/office/drawing/2014/main" id="{8F3CF0E7-4B43-ABEC-DD51-FCF6349E0E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489" y="3079751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58">
            <a:extLst>
              <a:ext uri="{FF2B5EF4-FFF2-40B4-BE49-F238E27FC236}">
                <a16:creationId xmlns:a16="http://schemas.microsoft.com/office/drawing/2014/main" id="{71301B68-F8AA-FC0D-1FB2-22330C5EC292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774119" y="1826054"/>
            <a:ext cx="191212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ncer-specific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65">
            <a:extLst>
              <a:ext uri="{FF2B5EF4-FFF2-40B4-BE49-F238E27FC236}">
                <a16:creationId xmlns:a16="http://schemas.microsoft.com/office/drawing/2014/main" id="{3DEB8203-FFAF-23C3-C54E-B326701DD2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27384" y="3205163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309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274      216      133      86         47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 43         39        21        15        9          5</a:t>
            </a:r>
          </a:p>
        </p:txBody>
      </p:sp>
      <p:sp>
        <p:nvSpPr>
          <p:cNvPr id="42" name="テキスト ボックス 59">
            <a:extLst>
              <a:ext uri="{FF2B5EF4-FFF2-40B4-BE49-F238E27FC236}">
                <a16:creationId xmlns:a16="http://schemas.microsoft.com/office/drawing/2014/main" id="{9C469CD8-ECF9-830A-579D-7B4F3948BA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6936" y="1043608"/>
            <a:ext cx="231933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43" name="テキスト ボックス 61">
            <a:extLst>
              <a:ext uri="{FF2B5EF4-FFF2-40B4-BE49-F238E27FC236}">
                <a16:creationId xmlns:a16="http://schemas.microsoft.com/office/drawing/2014/main" id="{741B5396-CE95-2DB6-5E69-7FAC662B1E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0149" y="1763688"/>
            <a:ext cx="23463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  <p:sp>
        <p:nvSpPr>
          <p:cNvPr id="53" name="テキスト ボックス 99">
            <a:extLst>
              <a:ext uri="{FF2B5EF4-FFF2-40B4-BE49-F238E27FC236}">
                <a16:creationId xmlns:a16="http://schemas.microsoft.com/office/drawing/2014/main" id="{0460EC31-2D61-C7BB-9FDC-157232BC8A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0953" y="724906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5">
            <a:extLst>
              <a:ext uri="{FF2B5EF4-FFF2-40B4-BE49-F238E27FC236}">
                <a16:creationId xmlns:a16="http://schemas.microsoft.com/office/drawing/2014/main" id="{3FAA0C37-9E14-8997-02D0-732CCB0F67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5225" y="2661901"/>
            <a:ext cx="106362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8">
            <a:extLst>
              <a:ext uri="{FF2B5EF4-FFF2-40B4-BE49-F238E27FC236}">
                <a16:creationId xmlns:a16="http://schemas.microsoft.com/office/drawing/2014/main" id="{957CA0C2-9EF0-7600-F93E-89FD02781FCC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508210" y="1858810"/>
            <a:ext cx="191212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Recurrence-free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5">
            <a:extLst>
              <a:ext uri="{FF2B5EF4-FFF2-40B4-BE49-F238E27FC236}">
                <a16:creationId xmlns:a16="http://schemas.microsoft.com/office/drawing/2014/main" id="{F6A2249E-F683-77B5-9E2F-51D11F2B3B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1699" y="3203848"/>
            <a:ext cx="3465513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    309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274      216      133      86         47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      43         39        21        15        9          5</a:t>
            </a:r>
          </a:p>
        </p:txBody>
      </p:sp>
      <p:sp>
        <p:nvSpPr>
          <p:cNvPr id="21504" name="テキスト ボックス 59">
            <a:extLst>
              <a:ext uri="{FF2B5EF4-FFF2-40B4-BE49-F238E27FC236}">
                <a16:creationId xmlns:a16="http://schemas.microsoft.com/office/drawing/2014/main" id="{A31E8089-4744-EC59-AC39-DDA59C76D0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1730" y="1403648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&lt;10% loss</a:t>
            </a:r>
          </a:p>
        </p:txBody>
      </p:sp>
      <p:sp>
        <p:nvSpPr>
          <p:cNvPr id="21505" name="テキスト ボックス 61">
            <a:extLst>
              <a:ext uri="{FF2B5EF4-FFF2-40B4-BE49-F238E27FC236}">
                <a16:creationId xmlns:a16="http://schemas.microsoft.com/office/drawing/2014/main" id="{D244BA0C-3E91-3F59-E258-BA8129C400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1930" y="1875805"/>
            <a:ext cx="106362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≥10% loss</a:t>
            </a:r>
          </a:p>
        </p:txBody>
      </p:sp>
      <p:sp>
        <p:nvSpPr>
          <p:cNvPr id="11" name="テキスト ボックス 57">
            <a:extLst>
              <a:ext uri="{FF2B5EF4-FFF2-40B4-BE49-F238E27FC236}">
                <a16:creationId xmlns:a16="http://schemas.microsoft.com/office/drawing/2014/main" id="{2C45C29C-036B-E7F5-F443-79B3701E2A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1784" y="3078205"/>
            <a:ext cx="26622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               Time after surgery        (Years)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08446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44D9F71-9D1A-DB84-F694-E6F5A7C499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9448" y="1115616"/>
            <a:ext cx="3166780" cy="2160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A7EBBD65-4055-CC63-86E5-CF14A3948E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37" y="1115513"/>
            <a:ext cx="3166780" cy="2160000"/>
          </a:xfrm>
          <a:prstGeom prst="rect">
            <a:avLst/>
          </a:prstGeom>
        </p:spPr>
      </p:pic>
      <p:sp>
        <p:nvSpPr>
          <p:cNvPr id="21509" name="テキスト ボックス 4">
            <a:extLst>
              <a:ext uri="{FF2B5EF4-FFF2-40B4-BE49-F238E27FC236}">
                <a16:creationId xmlns:a16="http://schemas.microsoft.com/office/drawing/2014/main" id="{D1B97550-F10A-288B-5534-27C5E19276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3" y="128588"/>
            <a:ext cx="21685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5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10" name="テキスト ボックス 2">
            <a:extLst>
              <a:ext uri="{FF2B5EF4-FFF2-40B4-BE49-F238E27FC236}">
                <a16:creationId xmlns:a16="http://schemas.microsoft.com/office/drawing/2014/main" id="{9558CFD7-244E-ECCE-C897-70F0C09709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6992" y="692150"/>
            <a:ext cx="3098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13" name="テキスト ボックス 99">
            <a:extLst>
              <a:ext uri="{FF2B5EF4-FFF2-40B4-BE49-F238E27FC236}">
                <a16:creationId xmlns:a16="http://schemas.microsoft.com/office/drawing/2014/main" id="{5F351BCC-6D83-EB08-6EC5-161AEBEBD5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24" y="692150"/>
            <a:ext cx="2716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16" name="テキスト ボックス 57">
            <a:extLst>
              <a:ext uri="{FF2B5EF4-FFF2-40B4-BE49-F238E27FC236}">
                <a16:creationId xmlns:a16="http://schemas.microsoft.com/office/drawing/2014/main" id="{96F8E010-7905-0284-16A6-3451647159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3067" y="3014246"/>
            <a:ext cx="266223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Time after surgery        (Years)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17" name="テキスト ボックス 58">
            <a:extLst>
              <a:ext uri="{FF2B5EF4-FFF2-40B4-BE49-F238E27FC236}">
                <a16:creationId xmlns:a16="http://schemas.microsoft.com/office/drawing/2014/main" id="{9A674086-8AB4-EB2D-C46B-BE6D7FCD032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566329" y="1797763"/>
            <a:ext cx="18478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 rate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18" name="テキスト ボックス 65">
            <a:extLst>
              <a:ext uri="{FF2B5EF4-FFF2-40B4-BE49-F238E27FC236}">
                <a16:creationId xmlns:a16="http://schemas.microsoft.com/office/drawing/2014/main" id="{72AA4C14-56D0-33FE-61E5-1E4BB44BF0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2570" y="3205165"/>
            <a:ext cx="3243263" cy="1477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110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81          60          29          22           1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138       100          86          59          36           22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5 - 10% weight 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57         39          25          14            9             4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≥10% weight loss</a:t>
            </a:r>
          </a:p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ja-JP" sz="1000" dirty="0"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 38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24          17          12            8             5    </a:t>
            </a:r>
          </a:p>
        </p:txBody>
      </p:sp>
      <p:sp>
        <p:nvSpPr>
          <p:cNvPr id="21519" name="テキスト ボックス 61">
            <a:extLst>
              <a:ext uri="{FF2B5EF4-FFF2-40B4-BE49-F238E27FC236}">
                <a16:creationId xmlns:a16="http://schemas.microsoft.com/office/drawing/2014/main" id="{8FC5F9F0-E336-60C5-05BD-93E293EE04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7241" y="2597748"/>
            <a:ext cx="15382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 10% weight loss</a:t>
            </a:r>
          </a:p>
        </p:txBody>
      </p:sp>
      <p:sp>
        <p:nvSpPr>
          <p:cNvPr id="21520" name="テキスト ボックス 61">
            <a:extLst>
              <a:ext uri="{FF2B5EF4-FFF2-40B4-BE49-F238E27FC236}">
                <a16:creationId xmlns:a16="http://schemas.microsoft.com/office/drawing/2014/main" id="{71F91899-7CE9-55C1-86EA-36C578A687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7241" y="2381848"/>
            <a:ext cx="15382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5 - 10% weight  loss</a:t>
            </a:r>
          </a:p>
        </p:txBody>
      </p:sp>
      <p:sp>
        <p:nvSpPr>
          <p:cNvPr id="21521" name="テキスト ボックス 61">
            <a:extLst>
              <a:ext uri="{FF2B5EF4-FFF2-40B4-BE49-F238E27FC236}">
                <a16:creationId xmlns:a16="http://schemas.microsoft.com/office/drawing/2014/main" id="{F329414E-3B32-D127-31B0-34A6225010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7241" y="2165948"/>
            <a:ext cx="15382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</a:t>
            </a:r>
          </a:p>
        </p:txBody>
      </p:sp>
      <p:sp>
        <p:nvSpPr>
          <p:cNvPr id="21522" name="テキスト ボックス 61">
            <a:extLst>
              <a:ext uri="{FF2B5EF4-FFF2-40B4-BE49-F238E27FC236}">
                <a16:creationId xmlns:a16="http://schemas.microsoft.com/office/drawing/2014/main" id="{E0D3CCDB-8C93-A2E5-620A-E21EB7E57C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46290" y="1950046"/>
            <a:ext cx="15367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</a:t>
            </a:r>
          </a:p>
        </p:txBody>
      </p:sp>
      <p:sp>
        <p:nvSpPr>
          <p:cNvPr id="21531" name="テキスト ボックス 62">
            <a:extLst>
              <a:ext uri="{FF2B5EF4-FFF2-40B4-BE49-F238E27FC236}">
                <a16:creationId xmlns:a16="http://schemas.microsoft.com/office/drawing/2014/main" id="{93D1D5EF-FD6B-4432-760F-DFDA6446E7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814" y="3014246"/>
            <a:ext cx="266223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Time after surgery        (Years)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32" name="テキスト ボックス 63">
            <a:extLst>
              <a:ext uri="{FF2B5EF4-FFF2-40B4-BE49-F238E27FC236}">
                <a16:creationId xmlns:a16="http://schemas.microsoft.com/office/drawing/2014/main" id="{BDFC65B5-1315-7C4D-5100-15239B57C82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722074" y="1798679"/>
            <a:ext cx="184785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verall survival rate</a:t>
            </a:r>
            <a:endParaRPr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33" name="テキスト ボックス 65">
            <a:extLst>
              <a:ext uri="{FF2B5EF4-FFF2-40B4-BE49-F238E27FC236}">
                <a16:creationId xmlns:a16="http://schemas.microsoft.com/office/drawing/2014/main" id="{5ADF7E7B-DCA8-8390-62B4-004A0C0662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951" y="3236915"/>
            <a:ext cx="3243263" cy="1477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    110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81          60          29          22           1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138       100          86          59          36           22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5 - 10% weight  los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57         39          25          14            9             4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≥10% weight loss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ja-JP" sz="1000" dirty="0"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 38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     24          17          12            8             5    </a:t>
            </a:r>
          </a:p>
        </p:txBody>
      </p:sp>
      <p:sp>
        <p:nvSpPr>
          <p:cNvPr id="21534" name="テキスト ボックス 61">
            <a:extLst>
              <a:ext uri="{FF2B5EF4-FFF2-40B4-BE49-F238E27FC236}">
                <a16:creationId xmlns:a16="http://schemas.microsoft.com/office/drawing/2014/main" id="{8427F32B-9BD0-69F6-AD25-AEAB775128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5700" y="2525715"/>
            <a:ext cx="15367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 10% weight loss</a:t>
            </a:r>
          </a:p>
        </p:txBody>
      </p:sp>
      <p:sp>
        <p:nvSpPr>
          <p:cNvPr id="21535" name="テキスト ボックス 61">
            <a:extLst>
              <a:ext uri="{FF2B5EF4-FFF2-40B4-BE49-F238E27FC236}">
                <a16:creationId xmlns:a16="http://schemas.microsoft.com/office/drawing/2014/main" id="{7EC73DD1-D622-A599-D227-EF39E29CA4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5700" y="2309815"/>
            <a:ext cx="15367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5 - 10% weight  loss</a:t>
            </a:r>
          </a:p>
        </p:txBody>
      </p:sp>
      <p:sp>
        <p:nvSpPr>
          <p:cNvPr id="21536" name="テキスト ボックス 61">
            <a:extLst>
              <a:ext uri="{FF2B5EF4-FFF2-40B4-BE49-F238E27FC236}">
                <a16:creationId xmlns:a16="http://schemas.microsoft.com/office/drawing/2014/main" id="{0ACF3E6A-F97A-DB8F-3034-0111235AAE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5700" y="2093915"/>
            <a:ext cx="15367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</a:t>
            </a:r>
          </a:p>
        </p:txBody>
      </p:sp>
      <p:sp>
        <p:nvSpPr>
          <p:cNvPr id="21537" name="テキスト ボックス 61">
            <a:extLst>
              <a:ext uri="{FF2B5EF4-FFF2-40B4-BE49-F238E27FC236}">
                <a16:creationId xmlns:a16="http://schemas.microsoft.com/office/drawing/2014/main" id="{97D2F3B7-1B6B-C0CE-9EC3-55BF99658B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3162" y="1878013"/>
            <a:ext cx="153828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</a:t>
            </a: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238BB623-DDF3-C840-B769-F0CE06ABB557}"/>
              </a:ext>
            </a:extLst>
          </p:cNvPr>
          <p:cNvCxnSpPr/>
          <p:nvPr/>
        </p:nvCxnSpPr>
        <p:spPr>
          <a:xfrm>
            <a:off x="692696" y="1979613"/>
            <a:ext cx="360363" cy="0"/>
          </a:xfrm>
          <a:prstGeom prst="line">
            <a:avLst/>
          </a:prstGeom>
          <a:ln w="158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CA10AAA5-BAB2-364F-B7F1-FFCA500111AE}"/>
              </a:ext>
            </a:extLst>
          </p:cNvPr>
          <p:cNvCxnSpPr/>
          <p:nvPr/>
        </p:nvCxnSpPr>
        <p:spPr>
          <a:xfrm>
            <a:off x="697537" y="2195513"/>
            <a:ext cx="3603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37088083-9086-1C44-9F86-90E62F26F417}"/>
              </a:ext>
            </a:extLst>
          </p:cNvPr>
          <p:cNvCxnSpPr/>
          <p:nvPr/>
        </p:nvCxnSpPr>
        <p:spPr>
          <a:xfrm>
            <a:off x="692698" y="2421825"/>
            <a:ext cx="360362" cy="0"/>
          </a:xfrm>
          <a:prstGeom prst="line">
            <a:avLst/>
          </a:prstGeom>
          <a:ln w="158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EA7D23FE-E235-E44D-ACBF-E82E8ED60022}"/>
              </a:ext>
            </a:extLst>
          </p:cNvPr>
          <p:cNvCxnSpPr/>
          <p:nvPr/>
        </p:nvCxnSpPr>
        <p:spPr>
          <a:xfrm>
            <a:off x="692698" y="2641600"/>
            <a:ext cx="360362" cy="0"/>
          </a:xfrm>
          <a:prstGeom prst="line">
            <a:avLst/>
          </a:prstGeom>
          <a:ln w="158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6A220619-55F5-1EE9-41D5-730EB6072456}"/>
              </a:ext>
            </a:extLst>
          </p:cNvPr>
          <p:cNvCxnSpPr/>
          <p:nvPr/>
        </p:nvCxnSpPr>
        <p:spPr>
          <a:xfrm>
            <a:off x="3922045" y="2051646"/>
            <a:ext cx="360363" cy="0"/>
          </a:xfrm>
          <a:prstGeom prst="line">
            <a:avLst/>
          </a:prstGeom>
          <a:ln w="158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69A07BA7-E249-B143-8693-CDE0268B510E}"/>
              </a:ext>
            </a:extLst>
          </p:cNvPr>
          <p:cNvCxnSpPr/>
          <p:nvPr/>
        </p:nvCxnSpPr>
        <p:spPr>
          <a:xfrm>
            <a:off x="3926886" y="2267546"/>
            <a:ext cx="3603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432CCE5-7DCD-4C6C-D1D4-E9AB55FDCD18}"/>
              </a:ext>
            </a:extLst>
          </p:cNvPr>
          <p:cNvCxnSpPr/>
          <p:nvPr/>
        </p:nvCxnSpPr>
        <p:spPr>
          <a:xfrm>
            <a:off x="3922045" y="2493858"/>
            <a:ext cx="360362" cy="0"/>
          </a:xfrm>
          <a:prstGeom prst="line">
            <a:avLst/>
          </a:prstGeom>
          <a:ln w="158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2193627F-9970-B0F2-B98B-14366E924B11}"/>
              </a:ext>
            </a:extLst>
          </p:cNvPr>
          <p:cNvCxnSpPr/>
          <p:nvPr/>
        </p:nvCxnSpPr>
        <p:spPr>
          <a:xfrm>
            <a:off x="3922045" y="2713633"/>
            <a:ext cx="360362" cy="0"/>
          </a:xfrm>
          <a:prstGeom prst="line">
            <a:avLst/>
          </a:prstGeom>
          <a:ln w="158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61">
            <a:extLst>
              <a:ext uri="{FF2B5EF4-FFF2-40B4-BE49-F238E27FC236}">
                <a16:creationId xmlns:a16="http://schemas.microsoft.com/office/drawing/2014/main" id="{BC1B015C-38C2-575C-0F6C-4E748C08A2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1819" y="5009953"/>
            <a:ext cx="3579591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 vs. 0 - 5% weight loss                 n.s.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 vs. 5 - 10% weight  loss              n.s.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 vs. ≥ 10% weight loss          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i="1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		                 P</a:t>
            </a: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 = 0.029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 vs. 5 - 10% weight  loss    n.s.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 vs. ≥ 10% weight loss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i="1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		                 P</a:t>
            </a: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 = 0.029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5 - 10% weight loss vs. ≥ 10% weight loss     n.s. </a:t>
            </a:r>
          </a:p>
        </p:txBody>
      </p:sp>
      <p:sp>
        <p:nvSpPr>
          <p:cNvPr id="3" name="テキスト ボックス 61">
            <a:extLst>
              <a:ext uri="{FF2B5EF4-FFF2-40B4-BE49-F238E27FC236}">
                <a16:creationId xmlns:a16="http://schemas.microsoft.com/office/drawing/2014/main" id="{60C87763-D826-10FF-89E3-808E38D281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634" y="5008324"/>
            <a:ext cx="3701107" cy="1477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 vs. 0 - 5% weight loss                 n.s.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 vs. 5 - 10% weight  loss              n.s.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Weight gain vs. ≥ 10% weight loss          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i="1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		                P</a:t>
            </a: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 = 0.004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 vs. 5 - 10% weight  loss    n.s.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0 - 5% weight loss vs. ≥ 10% weight loss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i="1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		                P</a:t>
            </a: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 = 0.002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5 - 10% weight loss vs. ≥ 10% weight loss.    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000" i="1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		                P</a:t>
            </a:r>
            <a:r>
              <a:rPr lang="en-US" altLang="ja-JP" sz="1000" dirty="0">
                <a:latin typeface="メイリオ" panose="020B0604030504040204" pitchFamily="34" charset="-128"/>
                <a:ea typeface="メイリオ" panose="020B0604030504040204" pitchFamily="34" charset="-128"/>
                <a:cs typeface="Calibri" panose="020F0502020204030204" pitchFamily="34" charset="0"/>
              </a:rPr>
              <a:t> = 0.034        </a:t>
            </a:r>
          </a:p>
        </p:txBody>
      </p:sp>
    </p:spTree>
    <p:extLst>
      <p:ext uri="{BB962C8B-B14F-4D97-AF65-F5344CB8AC3E}">
        <p14:creationId xmlns:p14="http://schemas.microsoft.com/office/powerpoint/2010/main" val="1988077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493</TotalTime>
  <Words>847</Words>
  <Application>Microsoft Office PowerPoint</Application>
  <PresentationFormat>On-screen Show (4:3)</PresentationFormat>
  <Paragraphs>169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ＭＳ Ｐゴシック</vt:lpstr>
      <vt:lpstr>游ゴシック</vt:lpstr>
      <vt:lpstr>Arial</vt:lpstr>
      <vt:lpstr>Arial Unicode MS</vt:lpstr>
      <vt:lpstr>Calibri</vt:lpstr>
      <vt:lpstr>メイリオ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ya abe</dc:creator>
  <cp:lastModifiedBy>Rohini S</cp:lastModifiedBy>
  <cp:revision>181</cp:revision>
  <dcterms:created xsi:type="dcterms:W3CDTF">2016-12-27T14:31:57Z</dcterms:created>
  <dcterms:modified xsi:type="dcterms:W3CDTF">2025-12-15T06:12:11Z</dcterms:modified>
</cp:coreProperties>
</file>